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310437-C599-4D4E-AD5C-A16A4D6DEF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8BD8E-33DC-4605-A20B-D16875D59F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8D9C08-F32E-406D-9B96-086509C439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EA93F8-12E5-4E89-8686-6186EB0DC1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0AE6A1A-93B4-47F4-9509-F0CF2B296D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0" spc="-1" strike="noStrike">
              <a:solidFill>
                <a:srgbClr val="ccec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8049631-1510-4547-BCC1-4867C99A49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BE9980D-8932-4E9A-B299-0F7F268871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7020623-349F-4731-9F85-F635754C57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EC530CE-F128-4163-9B81-3BB77C4A78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subTitle"/>
          </p:nvPr>
        </p:nvSpPr>
        <p:spPr>
          <a:xfrm>
            <a:off x="228600" y="45684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0" spc="-1" strike="noStrike">
              <a:solidFill>
                <a:srgbClr val="ccec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EF38D46-A13F-436F-B0D7-6B38E90B9B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1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329499D-0327-4A2C-9636-1F688FC383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0" spc="-1" strike="noStrike">
              <a:solidFill>
                <a:srgbClr val="ccec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E64C5-0AE5-4633-808F-10AD55D041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5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9C60FD3-3C1E-4A5B-8AFD-76A45C9883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A629E2B-73BB-4630-9374-E4BC4862F5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F0D02B4-182E-42F0-9765-DE38D6DEAD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6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7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AD435EF-E737-4A50-B98D-38DD3DDC0C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1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2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3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4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690F13E-F207-438D-A15E-711D49F0D5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4DCDFC-21D1-4C8F-A1C9-F874527EAF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6BB955-BA44-4588-AA9E-F910FA0F8E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35630-69E2-426A-9180-46DAACADD1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228600" y="45684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000" spc="-1" strike="noStrike">
              <a:solidFill>
                <a:srgbClr val="ccec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FEA32-44AB-423E-AD4B-E6A9AF1023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C2C20C-8DA6-4E46-8DB8-F76313F879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60176-4495-46D3-B8C7-9A317755DC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DC48FB-4881-4D01-8825-91E3F2830E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ffff"/>
                </a:solidFill>
                <a:latin typeface="Tahoma"/>
              </a:rPr>
              <a:t>Click to edit the title text format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1" marL="735480" indent="-282960">
              <a:spcBef>
                <a:spcPts val="799"/>
              </a:spcBef>
              <a:buClr>
                <a:srgbClr val="ccffff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2" marL="1131480" indent="-226080">
              <a:spcBef>
                <a:spcPts val="799"/>
              </a:spcBef>
              <a:buClr>
                <a:srgbClr val="cc99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3" marL="1584000" indent="-226080">
              <a:spcBef>
                <a:spcPts val="799"/>
              </a:spcBef>
              <a:buClr>
                <a:srgbClr val="ffffff"/>
              </a:buClr>
              <a:buFont typeface="Tahom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4" marL="2036520" indent="-226080">
              <a:spcBef>
                <a:spcPts val="799"/>
              </a:spcBef>
              <a:buClr>
                <a:srgbClr val="ccffff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54ACF2-BF5B-48D8-AAA7-0D3D5DDD3F3F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"/>
          <p:cNvSpPr/>
          <p:nvPr/>
        </p:nvSpPr>
        <p:spPr>
          <a:xfrm>
            <a:off x="0" y="1638360"/>
            <a:ext cx="3343320" cy="122040"/>
          </a:xfrm>
          <a:prstGeom prst="rect">
            <a:avLst/>
          </a:prstGeom>
          <a:solidFill>
            <a:srgbClr val="000066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"/>
          <p:cNvSpPr/>
          <p:nvPr/>
        </p:nvSpPr>
        <p:spPr>
          <a:xfrm>
            <a:off x="0" y="0"/>
            <a:ext cx="825480" cy="6858000"/>
          </a:xfrm>
          <a:prstGeom prst="rect">
            <a:avLst/>
          </a:prstGeom>
          <a:solidFill>
            <a:srgbClr val="ccffff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990360" y="1171440"/>
            <a:ext cx="7467480" cy="210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600" spc="-1" strike="noStrike">
                <a:solidFill>
                  <a:srgbClr val="ccffff"/>
                </a:solidFill>
                <a:latin typeface="Tahoma"/>
              </a:rPr>
              <a:t>Click to edit the title text format</a:t>
            </a:r>
            <a:endParaRPr b="0" lang="en-US" sz="66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dt" idx="4"/>
          </p:nvPr>
        </p:nvSpPr>
        <p:spPr>
          <a:xfrm>
            <a:off x="837720" y="6248520"/>
            <a:ext cx="1752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ccecff"/>
                </a:solidFill>
                <a:latin typeface="Times New Roman"/>
              </a:defRPr>
            </a:lvl1pPr>
          </a:lstStyle>
          <a:p>
            <a:pPr indent="0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ccecff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ftr" idx="5"/>
          </p:nvPr>
        </p:nvSpPr>
        <p:spPr>
          <a:xfrm>
            <a:off x="3276360" y="624852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ccecff"/>
                </a:solidFill>
                <a:latin typeface="Times New Roman"/>
              </a:defRPr>
            </a:lvl1pPr>
          </a:lstStyle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ccecff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sldNum" idx="6"/>
          </p:nvPr>
        </p:nvSpPr>
        <p:spPr>
          <a:xfrm>
            <a:off x="6933960" y="6248520"/>
            <a:ext cx="1904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ccecff"/>
                </a:solidFill>
                <a:latin typeface="Times New Roman"/>
              </a:defRPr>
            </a:lvl1pPr>
          </a:lstStyle>
          <a:p>
            <a:pPr indent="0" algn="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516A92-9E22-4B74-B722-405AC9AF7529}" type="slidenum">
              <a:rPr b="0" lang="en-US" sz="1400" spc="-1" strike="noStrike">
                <a:solidFill>
                  <a:srgbClr val="ccec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0" y="3543480"/>
            <a:ext cx="3343320" cy="122040"/>
          </a:xfrm>
          <a:prstGeom prst="rect">
            <a:avLst/>
          </a:prstGeom>
          <a:solidFill>
            <a:srgbClr val="000066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8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ccecff"/>
                </a:solidFill>
                <a:latin typeface="Tahoma"/>
              </a:rPr>
              <a:t>Click to edit the outline text format</a:t>
            </a:r>
            <a:endParaRPr b="0" lang="en-US" sz="4000" spc="-1" strike="noStrike">
              <a:solidFill>
                <a:srgbClr val="ccecff"/>
              </a:solidFill>
              <a:latin typeface="Tahoma"/>
            </a:endParaRPr>
          </a:p>
          <a:p>
            <a:pPr lvl="1" marL="457200"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Second Outline Level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lvl="2" marL="914400" algn="ctr">
              <a:spcBef>
                <a:spcPts val="601"/>
              </a:spcBef>
              <a:buClr>
                <a:srgbClr val="cc99ff"/>
              </a:buClr>
              <a:buSzPct val="65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ahoma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lvl="3" marL="1371600" algn="ctr">
              <a:spcBef>
                <a:spcPts val="499"/>
              </a:spcBef>
              <a:buClr>
                <a:srgbClr val="ffffff"/>
              </a:buClr>
              <a:buFont typeface="Tahoma"/>
              <a:buChar char="–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Four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4" marL="1828800" algn="ctr">
              <a:spcBef>
                <a:spcPts val="499"/>
              </a:spcBef>
              <a:buClr>
                <a:srgbClr val="ccffff"/>
              </a:buClr>
              <a:buSzPct val="55000"/>
              <a:buFont typeface="Wingdings" charset="2"/>
              <a:buChar char="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Fif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5" marL="1828800">
              <a:spcBef>
                <a:spcPts val="499"/>
              </a:spcBef>
              <a:buClr>
                <a:srgbClr val="ffffff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Six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6" marL="1828800">
              <a:spcBef>
                <a:spcPts val="499"/>
              </a:spcBef>
              <a:buClr>
                <a:srgbClr val="ffffff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Seven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5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5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hyperlink" Target="http://www.epage.ch/" TargetMode="External"/><Relationship Id="rId2" Type="http://schemas.openxmlformats.org/officeDocument/2006/relationships/slideLayout" Target="../slideLayouts/slideLayout14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5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5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"/>
          <p:cNvSpPr/>
          <p:nvPr/>
        </p:nvSpPr>
        <p:spPr>
          <a:xfrm>
            <a:off x="2209680" y="1905120"/>
            <a:ext cx="4572000" cy="447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Multimedia appendix to 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ffff"/>
                </a:solidFill>
                <a:latin typeface="Arial"/>
              </a:rPr>
              <a:t>"Use of the World Wide Web to implement clinical practice guidelines"</a:t>
            </a:r>
            <a:endParaRPr b="0" lang="en-US" sz="16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Published in J Med Internet Research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Vol. 5 / Iss. 2, 2003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http://www.jmir.org/2003/2/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© J Med Internet Res &amp; 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JG Jeannot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Centre électronique de Gestion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Verger-Rond 2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2000 Neuchâtel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Tél. 032 717 81 87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Fax 032 717 81 99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Mobile 079 615 0 635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ffff"/>
                </a:solidFill>
                <a:latin typeface="Arial"/>
              </a:rPr>
              <a:t>E-mail: jean-gabriel.jeannot@ne.ch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457200"/>
            <a:ext cx="7772400" cy="5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…</a:t>
            </a: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..following into the chapter..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pic>
        <p:nvPicPr>
          <p:cNvPr id="124" name="" descr=""/>
          <p:cNvPicPr/>
          <p:nvPr/>
        </p:nvPicPr>
        <p:blipFill>
          <a:blip r:embed="rId1"/>
          <a:stretch/>
        </p:blipFill>
        <p:spPr>
          <a:xfrm>
            <a:off x="914400" y="1295280"/>
            <a:ext cx="7400880" cy="5267520"/>
          </a:xfrm>
          <a:prstGeom prst="rect">
            <a:avLst/>
          </a:prstGeom>
          <a:ln w="0">
            <a:noFill/>
          </a:ln>
        </p:spPr>
      </p:pic>
      <p:sp>
        <p:nvSpPr>
          <p:cNvPr id="125" name=""/>
          <p:cNvSpPr/>
          <p:nvPr/>
        </p:nvSpPr>
        <p:spPr>
          <a:xfrm>
            <a:off x="3048120" y="4114800"/>
            <a:ext cx="1752480" cy="304920"/>
          </a:xfrm>
          <a:prstGeom prst="ellipse">
            <a:avLst/>
          </a:prstGeom>
          <a:noFill/>
          <a:ln w="38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5105520" y="4876920"/>
            <a:ext cx="2590560" cy="64152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66ff"/>
                </a:solidFill>
                <a:latin typeface="Lucida Sans"/>
              </a:rPr>
              <a:t>According to the Clinical situation, choose :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ff0066"/>
                </a:solidFill>
                <a:latin typeface="Lucida Sans"/>
              </a:rPr>
              <a:t>« No intestinal metaplasia »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 rot="13840200">
            <a:off x="4114800" y="4572000"/>
            <a:ext cx="838080" cy="380880"/>
          </a:xfrm>
          <a:custGeom>
            <a:avLst/>
            <a:gdLst>
              <a:gd name="textAreaLeft" fmla="*/ 130680 w 838080"/>
              <a:gd name="textAreaRight" fmla="*/ 733320 w 838080"/>
              <a:gd name="textAreaTop" fmla="*/ 95040 h 380880"/>
              <a:gd name="textAreaBottom" fmla="*/ 285840 h 380880"/>
            </a:gdLst>
            <a:ahLst/>
            <a:rect l="textAreaLeft" t="textAreaTop" r="textAreaRight" b="textAreaBottom"/>
            <a:pathLst>
              <a:path w="21600" h="21600">
                <a:moveTo>
                  <a:pt x="3375" y="5400"/>
                </a:moveTo>
                <a:lnTo>
                  <a:pt x="16200" y="5400"/>
                </a:ln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16200" y="16200"/>
                </a:lnTo>
                <a:lnTo>
                  <a:pt x="3375" y="16200"/>
                </a:lnTo>
                <a:close/>
              </a:path>
              <a:path w="21600" h="21600">
                <a:moveTo>
                  <a:pt x="0" y="5400"/>
                </a:moveTo>
                <a:lnTo>
                  <a:pt x="675" y="5400"/>
                </a:lnTo>
                <a:lnTo>
                  <a:pt x="675" y="16200"/>
                </a:lnTo>
                <a:lnTo>
                  <a:pt x="0" y="16200"/>
                </a:lnTo>
                <a:close/>
              </a:path>
              <a:path w="21600" h="21600">
                <a:moveTo>
                  <a:pt x="1350" y="5400"/>
                </a:moveTo>
                <a:lnTo>
                  <a:pt x="2700" y="5400"/>
                </a:lnTo>
                <a:lnTo>
                  <a:pt x="2700" y="16200"/>
                </a:lnTo>
                <a:lnTo>
                  <a:pt x="1350" y="16200"/>
                </a:lnTo>
                <a:close/>
              </a:path>
            </a:pathLst>
          </a:custGeom>
          <a:solidFill>
            <a:srgbClr val="ff0066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timing>
    <p:tnLst>
      <p:par>
        <p:cTn id="183" dur="indefinite" restart="never" nodeType="tmRoot">
          <p:childTnLst>
            <p:seq>
              <p:cTn id="184" dur="indefinite" nodeType="mainSeq">
                <p:childTnLst>
                  <p:par>
                    <p:cTn id="185" fill="hold">
                      <p:stCondLst>
                        <p:cond delay="0"/>
                      </p:stCondLst>
                      <p:childTnLst>
                        <p:par>
                          <p:cTn id="186" fill="hold">
                            <p:stCondLst>
                              <p:cond delay="0"/>
                            </p:stCondLst>
                            <p:childTnLst>
                              <p:par>
                                <p:cTn id="187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8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89" fill="hold">
                            <p:stCondLst>
                              <p:cond delay="1500"/>
                            </p:stCondLst>
                            <p:childTnLst>
                              <p:par>
                                <p:cTn id="190" nodeType="afterEffect" fill="hold" presetClass="entr" presetID="4" presetSubtype="32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9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out)" transition="in">
                                      <p:cBhvr additive="repl">
                                        <p:cTn id="192" dur="500"/>
                                        <p:tgtEl>
                                          <p:spTgt spid="1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3" fill="hold">
                            <p:stCondLst>
                              <p:cond delay="4000"/>
                            </p:stCondLst>
                            <p:childTnLst>
                              <p:par>
                                <p:cTn id="194" nodeType="afterEffect" fill="hold" presetClass="entr" presetID="2" presetSubtype="4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1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6" dur="500" fill="hold"/>
                                        <p:tgtEl>
                                          <p:spTgt spid="12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97" dur="500" fill="hold"/>
                                        <p:tgtEl>
                                          <p:spTgt spid="12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8" fill="hold">
                            <p:stCondLst>
                              <p:cond delay="7500"/>
                            </p:stCondLst>
                            <p:childTnLst>
                              <p:par>
                                <p:cTn id="199" nodeType="afterEffect" fill="hold" presetClass="entr" presetID="4" presetSubtype="16">
                                  <p:stCondLst>
                                    <p:cond delay="5000"/>
                                  </p:stCondLst>
                                  <p:childTnLst>
                                    <p:set>
                                      <p:cBhvr>
                                        <p:cTn id="2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in)" transition="in">
                                      <p:cBhvr additive="repl">
                                        <p:cTn id="201" dur="500"/>
                                        <p:tgtEl>
                                          <p:spTgt spid="1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set>
                                <p:cBhvr>
                                  <p:cTn id="202" dur="1" fill="hold">
                                    <p:stCondLst>
                                      <p:cond delay="5000"/>
                                    </p:stCondLst>
                                  </p:cTn>
                                  <p:tgtEl>
                                    <p:spTgt spid="126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  <p:par>
                          <p:cTn id="203" fill="hold">
                            <p:stCondLst>
                              <p:cond delay="13000"/>
                            </p:stCondLst>
                            <p:childTnLst>
                              <p:par>
                                <p:cTn id="204" nodeType="afterEffect" fill="hold" presetClass="entr" presetID="17" presetSubtype="10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20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repl">
                                        <p:cTn id="206" dur="500" fill="hold"/>
                                        <p:tgtEl>
                                          <p:spTgt spid="12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207" dur="500" fill="hold"/>
                                        <p:tgtEl>
                                          <p:spTgt spid="12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set>
                                <p:cBhvr>
                                  <p:cTn id="208" dur="1" fill="hold">
                                    <p:stCondLst>
                                      <p:cond delay="3000"/>
                                    </p:stCondLst>
                                  </p:cTn>
                                  <p:tgtEl>
                                    <p:spTgt spid="127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304920" y="30456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Results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pic>
        <p:nvPicPr>
          <p:cNvPr id="129" name="" descr=""/>
          <p:cNvPicPr/>
          <p:nvPr/>
        </p:nvPicPr>
        <p:blipFill>
          <a:blip r:embed="rId1"/>
          <a:stretch/>
        </p:blipFill>
        <p:spPr>
          <a:xfrm>
            <a:off x="1143000" y="1324080"/>
            <a:ext cx="7772400" cy="5533920"/>
          </a:xfrm>
          <a:prstGeom prst="rect">
            <a:avLst/>
          </a:prstGeom>
          <a:ln w="0">
            <a:noFill/>
          </a:ln>
        </p:spPr>
      </p:pic>
      <p:sp>
        <p:nvSpPr>
          <p:cNvPr id="130" name=""/>
          <p:cNvSpPr/>
          <p:nvPr/>
        </p:nvSpPr>
        <p:spPr>
          <a:xfrm>
            <a:off x="3429000" y="3581280"/>
            <a:ext cx="1752480" cy="381240"/>
          </a:xfrm>
          <a:prstGeom prst="ellipse">
            <a:avLst/>
          </a:prstGeom>
          <a:noFill/>
          <a:ln w="38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4343400" y="990720"/>
            <a:ext cx="3809880" cy="106740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0066ff"/>
                </a:solidFill>
                <a:latin typeface="Lucida Sans"/>
              </a:rPr>
              <a:t>The results giving by the panelists is that</a:t>
            </a:r>
            <a:endParaRPr b="0" lang="en-US" sz="1600" spc="-1" strike="noStrike">
              <a:solidFill>
                <a:srgbClr val="ffffff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600" spc="-1" strike="noStrike">
                <a:solidFill>
                  <a:srgbClr val="ff0066"/>
                </a:solidFill>
                <a:latin typeface="Lucida Sans"/>
              </a:rPr>
              <a:t>Indication for gastroscopy is INAPROPRIATE</a:t>
            </a:r>
            <a:endParaRPr b="0" lang="en-US" sz="16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 rot="8259600">
            <a:off x="4997160" y="2825640"/>
            <a:ext cx="1371600" cy="533520"/>
          </a:xfrm>
          <a:custGeom>
            <a:avLst/>
            <a:gdLst>
              <a:gd name="textAreaLeft" fmla="*/ 214200 w 1371600"/>
              <a:gd name="textAreaRight" fmla="*/ 1200240 w 1371600"/>
              <a:gd name="textAreaTop" fmla="*/ 133200 h 533520"/>
              <a:gd name="textAreaBottom" fmla="*/ 400320 h 533520"/>
            </a:gdLst>
            <a:ahLst/>
            <a:rect l="textAreaLeft" t="textAreaTop" r="textAreaRight" b="textAreaBottom"/>
            <a:pathLst>
              <a:path w="21600" h="21600">
                <a:moveTo>
                  <a:pt x="3375" y="5400"/>
                </a:moveTo>
                <a:lnTo>
                  <a:pt x="16200" y="5400"/>
                </a:ln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16200" y="16200"/>
                </a:lnTo>
                <a:lnTo>
                  <a:pt x="3375" y="16200"/>
                </a:lnTo>
                <a:close/>
              </a:path>
              <a:path w="21600" h="21600">
                <a:moveTo>
                  <a:pt x="0" y="5400"/>
                </a:moveTo>
                <a:lnTo>
                  <a:pt x="675" y="5400"/>
                </a:lnTo>
                <a:lnTo>
                  <a:pt x="675" y="16200"/>
                </a:lnTo>
                <a:lnTo>
                  <a:pt x="0" y="16200"/>
                </a:lnTo>
                <a:close/>
              </a:path>
              <a:path w="21600" h="21600">
                <a:moveTo>
                  <a:pt x="1350" y="5400"/>
                </a:moveTo>
                <a:lnTo>
                  <a:pt x="2700" y="5400"/>
                </a:lnTo>
                <a:lnTo>
                  <a:pt x="2700" y="16200"/>
                </a:lnTo>
                <a:lnTo>
                  <a:pt x="1350" y="16200"/>
                </a:lnTo>
                <a:close/>
              </a:path>
            </a:pathLst>
          </a:custGeom>
          <a:solidFill>
            <a:srgbClr val="ff0066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timing>
    <p:tnLst>
      <p:par>
        <p:cTn id="209" dur="indefinite" restart="never" nodeType="tmRoot">
          <p:childTnLst>
            <p:seq>
              <p:cTn id="210" dur="indefinite" nodeType="mainSeq">
                <p:childTnLst>
                  <p:par>
                    <p:cTn id="211" fill="hold">
                      <p:stCondLst>
                        <p:cond delay="0"/>
                      </p:stCondLst>
                      <p:childTnLst>
                        <p:par>
                          <p:cTn id="212" fill="hold">
                            <p:stCondLst>
                              <p:cond delay="0"/>
                            </p:stCondLst>
                            <p:childTnLst>
                              <p:par>
                                <p:cTn id="213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21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5" fill="hold">
                            <p:stCondLst>
                              <p:cond delay="1500"/>
                            </p:stCondLst>
                            <p:childTnLst>
                              <p:par>
                                <p:cTn id="216" nodeType="afterEffect" fill="hold" presetClass="entr" presetID="4" presetSubtype="32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2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out)" transition="in">
                                      <p:cBhvr additive="repl">
                                        <p:cTn id="218" dur="500"/>
                                        <p:tgtEl>
                                          <p:spTgt spid="12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19" fill="hold">
                            <p:stCondLst>
                              <p:cond delay="4000"/>
                            </p:stCondLst>
                            <p:childTnLst>
                              <p:par>
                                <p:cTn id="220" nodeType="afterEffect" fill="hold" presetClass="entr" presetID="2" presetSubtype="2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2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22" dur="500" fill="hold"/>
                                        <p:tgtEl>
                                          <p:spTgt spid="13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23" dur="500" fill="hold"/>
                                        <p:tgtEl>
                                          <p:spTgt spid="13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4" fill="hold">
                            <p:stCondLst>
                              <p:cond delay="7500"/>
                            </p:stCondLst>
                            <p:childTnLst>
                              <p:par>
                                <p:cTn id="225" nodeType="afterEffect" fill="hold" presetClass="entr" presetID="22" presetSubtype="1">
                                  <p:stCondLst>
                                    <p:cond delay="5000"/>
                                  </p:stCondLst>
                                  <p:childTnLst>
                                    <p:set>
                                      <p:cBhvr>
                                        <p:cTn id="2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227" dur="500"/>
                                        <p:tgtEl>
                                          <p:spTgt spid="1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8" fill="hold">
                            <p:stCondLst>
                              <p:cond delay="13000"/>
                            </p:stCondLst>
                            <p:childTnLst>
                              <p:par>
                                <p:cTn id="229" nodeType="afterEffect" fill="hold" presetClass="entr" presetID="17" presetSubtype="10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2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repl">
                                        <p:cTn id="231" dur="500" fill="hold"/>
                                        <p:tgtEl>
                                          <p:spTgt spid="130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232" dur="500" fill="hold"/>
                                        <p:tgtEl>
                                          <p:spTgt spid="130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228240" y="45684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000" spc="-1" strike="noStrike">
                <a:solidFill>
                  <a:srgbClr val="ccffff"/>
                </a:solidFill>
                <a:latin typeface="Tahoma"/>
              </a:rPr>
              <a:t>About bibliographic research</a:t>
            </a:r>
            <a:endParaRPr b="0" lang="en-US" sz="40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ffff"/>
                </a:solidFill>
                <a:latin typeface="Tahoma"/>
              </a:rPr>
              <a:t>By clicking on the "references" button, the reader can access a review article on the subject of upper GI endoscopy in Barrett's oesophagus, as well as MEDLINE abstracts of related articles.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p:timing>
    <p:tnLst>
      <p:par>
        <p:cTn id="233" dur="indefinite" restart="never" nodeType="tmRoot">
          <p:childTnLst>
            <p:seq>
              <p:cTn id="234" dur="indefinite" nodeType="mainSeq">
                <p:childTnLst>
                  <p:par>
                    <p:cTn id="235" fill="hold">
                      <p:stCondLst>
                        <p:cond delay="0"/>
                      </p:stCondLst>
                      <p:childTnLst>
                        <p:par>
                          <p:cTn id="236" fill="hold">
                            <p:stCondLst>
                              <p:cond delay="0"/>
                            </p:stCondLst>
                            <p:childTnLst>
                              <p:par>
                                <p:cTn id="237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23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39" fill="hold">
                            <p:stCondLst>
                              <p:cond delay="1500"/>
                            </p:stCondLst>
                            <p:childTnLst>
                              <p:par>
                                <p:cTn id="240" nodeType="afterEffect" fill="hold" presetClass="entr" presetID="2" presetSubtype="8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2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42" dur="500" fill="hold"/>
                                        <p:tgtEl>
                                          <p:spTgt spid="13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3" dur="500" fill="hold"/>
                                        <p:tgtEl>
                                          <p:spTgt spid="13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304920" y="304560"/>
            <a:ext cx="7772400" cy="68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References button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pic>
        <p:nvPicPr>
          <p:cNvPr id="136" name="" descr=""/>
          <p:cNvPicPr/>
          <p:nvPr/>
        </p:nvPicPr>
        <p:blipFill>
          <a:blip r:embed="rId1"/>
          <a:stretch/>
        </p:blipFill>
        <p:spPr>
          <a:xfrm>
            <a:off x="1143000" y="1324080"/>
            <a:ext cx="7772400" cy="5533920"/>
          </a:xfrm>
          <a:prstGeom prst="rect">
            <a:avLst/>
          </a:prstGeom>
          <a:ln w="0">
            <a:noFill/>
          </a:ln>
        </p:spPr>
      </p:pic>
      <p:sp>
        <p:nvSpPr>
          <p:cNvPr id="137" name=""/>
          <p:cNvSpPr/>
          <p:nvPr/>
        </p:nvSpPr>
        <p:spPr>
          <a:xfrm>
            <a:off x="4572000" y="5867280"/>
            <a:ext cx="1066680" cy="381240"/>
          </a:xfrm>
          <a:prstGeom prst="ellipse">
            <a:avLst/>
          </a:prstGeom>
          <a:noFill/>
          <a:ln w="38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 rot="8259600">
            <a:off x="5181120" y="4952880"/>
            <a:ext cx="1371600" cy="533520"/>
          </a:xfrm>
          <a:custGeom>
            <a:avLst/>
            <a:gdLst>
              <a:gd name="textAreaLeft" fmla="*/ 214200 w 1371600"/>
              <a:gd name="textAreaRight" fmla="*/ 1200240 w 1371600"/>
              <a:gd name="textAreaTop" fmla="*/ 133200 h 533520"/>
              <a:gd name="textAreaBottom" fmla="*/ 400320 h 533520"/>
            </a:gdLst>
            <a:ahLst/>
            <a:rect l="textAreaLeft" t="textAreaTop" r="textAreaRight" b="textAreaBottom"/>
            <a:pathLst>
              <a:path w="21600" h="21600">
                <a:moveTo>
                  <a:pt x="3375" y="5400"/>
                </a:moveTo>
                <a:lnTo>
                  <a:pt x="16200" y="5400"/>
                </a:ln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16200" y="16200"/>
                </a:lnTo>
                <a:lnTo>
                  <a:pt x="3375" y="16200"/>
                </a:lnTo>
                <a:close/>
              </a:path>
              <a:path w="21600" h="21600">
                <a:moveTo>
                  <a:pt x="0" y="5400"/>
                </a:moveTo>
                <a:lnTo>
                  <a:pt x="675" y="5400"/>
                </a:lnTo>
                <a:lnTo>
                  <a:pt x="675" y="16200"/>
                </a:lnTo>
                <a:lnTo>
                  <a:pt x="0" y="16200"/>
                </a:lnTo>
                <a:close/>
              </a:path>
              <a:path w="21600" h="21600">
                <a:moveTo>
                  <a:pt x="1350" y="5400"/>
                </a:moveTo>
                <a:lnTo>
                  <a:pt x="2700" y="5400"/>
                </a:lnTo>
                <a:lnTo>
                  <a:pt x="2700" y="16200"/>
                </a:lnTo>
                <a:lnTo>
                  <a:pt x="1350" y="16200"/>
                </a:lnTo>
                <a:close/>
              </a:path>
            </a:pathLst>
          </a:custGeom>
          <a:solidFill>
            <a:srgbClr val="ff0066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timing>
    <p:tnLst>
      <p:par>
        <p:cTn id="244" dur="indefinite" restart="never" nodeType="tmRoot">
          <p:childTnLst>
            <p:seq>
              <p:cTn id="245" dur="indefinite" nodeType="mainSeq">
                <p:childTnLst>
                  <p:par>
                    <p:cTn id="246" fill="hold">
                      <p:stCondLst>
                        <p:cond delay="0"/>
                      </p:stCondLst>
                      <p:childTnLst>
                        <p:par>
                          <p:cTn id="247" fill="hold">
                            <p:stCondLst>
                              <p:cond delay="0"/>
                            </p:stCondLst>
                            <p:childTnLst>
                              <p:par>
                                <p:cTn id="248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24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0" fill="hold">
                            <p:stCondLst>
                              <p:cond delay="1500"/>
                            </p:stCondLst>
                            <p:childTnLst>
                              <p:par>
                                <p:cTn id="251" nodeType="afterEffect" fill="hold" presetClass="entr" presetID="4" presetSubtype="32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2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out)" transition="in">
                                      <p:cBhvr additive="repl">
                                        <p:cTn id="253" dur="500"/>
                                        <p:tgtEl>
                                          <p:spTgt spid="13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4" fill="hold">
                            <p:stCondLst>
                              <p:cond delay="4000"/>
                            </p:stCondLst>
                            <p:childTnLst>
                              <p:par>
                                <p:cTn id="255" nodeType="afterEffect" fill="hold" presetClass="entr" presetID="22" presetSubtype="1">
                                  <p:stCondLst>
                                    <p:cond delay="5000"/>
                                  </p:stCondLst>
                                  <p:childTnLst>
                                    <p:set>
                                      <p:cBhvr>
                                        <p:cTn id="2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wipe(up)" transition="in">
                                      <p:cBhvr additive="repl">
                                        <p:cTn id="257" dur="500"/>
                                        <p:tgtEl>
                                          <p:spTgt spid="1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58" fill="hold">
                            <p:stCondLst>
                              <p:cond delay="9500"/>
                            </p:stCondLst>
                            <p:childTnLst>
                              <p:par>
                                <p:cTn id="259" nodeType="afterEffect" fill="hold" presetClass="entr" presetID="17" presetSubtype="10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2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repl">
                                        <p:cTn id="261" dur="500" fill="hold"/>
                                        <p:tgtEl>
                                          <p:spTgt spid="137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262" dur="500" fill="hold"/>
                                        <p:tgtEl>
                                          <p:spTgt spid="137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title"/>
          </p:nvPr>
        </p:nvSpPr>
        <p:spPr>
          <a:xfrm>
            <a:off x="1371240" y="1568520"/>
            <a:ext cx="7086600" cy="210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Use of the World Wide Web to implement clinical practice guidelines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 type="subTitle"/>
          </p:nvPr>
        </p:nvSpPr>
        <p:spPr>
          <a:xfrm>
            <a:off x="1447920" y="4038120"/>
            <a:ext cx="6400800" cy="175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lnSpc>
                <a:spcPct val="8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ccecff"/>
                </a:solidFill>
                <a:latin typeface="Tahoma"/>
              </a:rPr>
              <a:t>Example : How to use the site </a:t>
            </a:r>
            <a:r>
              <a:rPr b="0" lang="fr-FR" sz="2400" spc="-1" strike="noStrike" u="sng">
                <a:solidFill>
                  <a:srgbClr val="99ccff"/>
                </a:solidFill>
                <a:uFillTx/>
                <a:latin typeface="Tahoma"/>
                <a:hlinkClick r:id="rId1"/>
              </a:rPr>
              <a:t>www.epage.ch</a:t>
            </a:r>
            <a:endParaRPr b="0" lang="en-US" sz="2400" spc="-1" strike="noStrike">
              <a:solidFill>
                <a:srgbClr val="ccecff"/>
              </a:solidFill>
              <a:latin typeface="Tahoma"/>
            </a:endParaRPr>
          </a:p>
          <a:p>
            <a:pPr indent="0" algn="ctr">
              <a:lnSpc>
                <a:spcPct val="8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ccecff"/>
                </a:solidFill>
                <a:latin typeface="Tahoma"/>
              </a:rPr>
              <a:t>(European Panel on the Appropiateness of Gastrointestinal Endoscopy) </a:t>
            </a:r>
            <a:endParaRPr b="0" lang="en-US" sz="2400" spc="-1" strike="noStrike">
              <a:solidFill>
                <a:srgbClr val="ccecff"/>
              </a:solidFill>
              <a:latin typeface="Tahoma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228600" y="457200"/>
            <a:ext cx="77724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Summary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ffff"/>
                </a:solidFill>
                <a:latin typeface="Tahoma"/>
              </a:rPr>
              <a:t>Description of the clinical situation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ffff"/>
                </a:solidFill>
                <a:latin typeface="Tahoma"/>
              </a:rPr>
              <a:t>Connection to the Web site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ffff"/>
                </a:solidFill>
                <a:latin typeface="Tahoma"/>
              </a:rPr>
              <a:t>Choose the procedure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ffff"/>
                </a:solidFill>
                <a:latin typeface="Tahoma"/>
              </a:rPr>
              <a:t>Choose the chapter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ffff"/>
                </a:solidFill>
                <a:latin typeface="Tahoma"/>
              </a:rPr>
              <a:t>Advance into the chapter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ffff"/>
                </a:solidFill>
                <a:latin typeface="Tahoma"/>
              </a:rPr>
              <a:t>About bibliography research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0" name=""/>
          <p:cNvSpPr/>
          <p:nvPr/>
        </p:nvSpPr>
        <p:spPr>
          <a:xfrm>
            <a:off x="533520" y="5867280"/>
            <a:ext cx="8305560" cy="83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1500"/>
                            </p:stCondLst>
                            <p:childTnLst>
                              <p:par>
                                <p:cTn id="8" nodeType="afterEffect" fill="hold" presetClass="entr" presetID="2" presetSubtype="8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8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4000"/>
                            </p:stCondLst>
                            <p:childTnLst>
                              <p:par>
                                <p:cTn id="13" nodeType="afterEffect" fill="hold" presetClass="entr" presetID="2" presetSubtype="8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8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8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>
                            <p:stCondLst>
                              <p:cond delay="6500"/>
                            </p:stCondLst>
                            <p:childTnLst>
                              <p:par>
                                <p:cTn id="18" nodeType="afterEffect" fill="hold" presetClass="entr" presetID="2" presetSubtype="8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8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1" dur="500" fill="hold"/>
                                        <p:tgtEl>
                                          <p:spTgt spid="8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" fill="hold">
                            <p:stCondLst>
                              <p:cond delay="9000"/>
                            </p:stCondLst>
                            <p:childTnLst>
                              <p:par>
                                <p:cTn id="23" nodeType="afterEffect" fill="hold" presetClass="entr" presetID="2" presetSubtype="8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" dur="500" fill="hold"/>
                                        <p:tgtEl>
                                          <p:spTgt spid="8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6" dur="500" fill="hold"/>
                                        <p:tgtEl>
                                          <p:spTgt spid="8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7" fill="hold">
                            <p:stCondLst>
                              <p:cond delay="11500"/>
                            </p:stCondLst>
                            <p:childTnLst>
                              <p:par>
                                <p:cTn id="28" nodeType="afterEffect" fill="hold" presetClass="entr" presetID="2" presetSubtype="8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0" dur="500" fill="hold"/>
                                        <p:tgtEl>
                                          <p:spTgt spid="8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1" dur="500" fill="hold"/>
                                        <p:tgtEl>
                                          <p:spTgt spid="8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2" fill="hold">
                            <p:stCondLst>
                              <p:cond delay="14000"/>
                            </p:stCondLst>
                            <p:childTnLst>
                              <p:par>
                                <p:cTn id="33" nodeType="afterEffect" fill="hold" presetClass="entr" presetID="2" presetSubtype="8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5" dur="500" fill="hold"/>
                                        <p:tgtEl>
                                          <p:spTgt spid="89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6" dur="500" fill="hold"/>
                                        <p:tgtEl>
                                          <p:spTgt spid="89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7" fill="hold">
                            <p:stCondLst>
                              <p:cond delay="16500"/>
                            </p:stCondLst>
                            <p:childTnLst>
                              <p:par>
                                <p:cTn id="38" nodeType="afterEffect" fill="hold" presetClass="entr" presetID="4" presetSubtype="16">
                                  <p:stCondLst>
                                    <p:cond delay="1000"/>
                                  </p:stCondLst>
                                  <p:endCondLst>
                                    <p:cond evt="begin"/>
                                  </p:end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in)" transition="in">
                                      <p:cBhvr additive="repl">
                                        <p:cTn id="40" dur="500"/>
                                        <p:tgtEl>
                                          <p:spTgt spid="9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A clinic situation …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685800" y="1828800"/>
            <a:ext cx="8229600" cy="322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ffff"/>
                </a:solidFill>
                <a:latin typeface="Tahoma"/>
              </a:rPr>
              <a:t>Your patient has a known Barrett’s esophagus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39480" indent="-3394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ffff"/>
                </a:solidFill>
                <a:latin typeface="Tahoma"/>
              </a:rPr>
              <a:t>He is asymptomatic, but had no gastroscopy for 3 years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marL="339480" indent="-339480">
              <a:spcBef>
                <a:spcPts val="799"/>
              </a:spcBef>
              <a:buClr>
                <a:srgbClr val="cc99ff"/>
              </a:buClr>
              <a:buSzPct val="80000"/>
              <a:buFont typeface="Wingdings" charset="2"/>
              <a:buChar char="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ffff"/>
                </a:solidFill>
                <a:latin typeface="Tahoma"/>
              </a:rPr>
              <a:t>The last exam does not show any intestinal metaplasy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p:timing>
    <p:tnLst>
      <p:par>
        <p:cTn id="41" dur="indefinite" restart="never" nodeType="tmRoot">
          <p:childTnLst>
            <p:seq>
              <p:cTn id="42" dur="indefinite" nodeType="mainSeq">
                <p:childTnLst>
                  <p:par>
                    <p:cTn id="43" fill="hold">
                      <p:stCondLst>
                        <p:cond delay="0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7" fill="hold">
                            <p:stCondLst>
                              <p:cond delay="1500"/>
                            </p:stCondLst>
                            <p:childTnLst>
                              <p:par>
                                <p:cTn id="48" nodeType="afterEffect" fill="hold" presetClass="entr" presetID="16" presetSubtype="42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arn(outHorizontal)" transition="in">
                                      <p:cBhvr additive="repl">
                                        <p:cTn id="50" dur="500"/>
                                        <p:tgtEl>
                                          <p:spTgt spid="9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1" fill="hold">
                            <p:stCondLst>
                              <p:cond delay="4000"/>
                            </p:stCondLst>
                            <p:childTnLst>
                              <p:par>
                                <p:cTn id="52" nodeType="afterEffect" fill="hold" presetClass="entr" presetID="16" presetSubtype="42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arn(outHorizontal)" transition="in">
                                      <p:cBhvr additive="repl">
                                        <p:cTn id="54" dur="500"/>
                                        <p:tgtEl>
                                          <p:spTgt spid="9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55" fill="hold">
                            <p:stCondLst>
                              <p:cond delay="6500"/>
                            </p:stCondLst>
                            <p:childTnLst>
                              <p:par>
                                <p:cTn id="56" nodeType="afterEffect" fill="hold" presetClass="entr" presetID="16" presetSubtype="42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5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arn(outHorizontal)" transition="in">
                                      <p:cBhvr additive="repl">
                                        <p:cTn id="58" dur="500"/>
                                        <p:tgtEl>
                                          <p:spTgt spid="92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ffff"/>
                </a:solidFill>
                <a:latin typeface="Tahoma"/>
              </a:rPr>
              <a:t>Question ?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ff0066"/>
              </a:buClr>
              <a:buSzPct val="80000"/>
              <a:buFont typeface="Wingdings" charset="2"/>
              <a:buChar char="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ff0066"/>
                </a:solidFill>
                <a:latin typeface="Tahoma"/>
              </a:rPr>
              <a:t> </a:t>
            </a:r>
            <a:r>
              <a:rPr b="0" lang="fr-FR" sz="3200" spc="-1" strike="noStrike">
                <a:solidFill>
                  <a:srgbClr val="ff0066"/>
                </a:solidFill>
                <a:latin typeface="Tahoma"/>
              </a:rPr>
              <a:t>Is there an indication for a new gastroscopy?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p:timing>
    <p:tnLst>
      <p:par>
        <p:cTn id="59" dur="indefinite" restart="never" nodeType="tmRoot">
          <p:childTnLst>
            <p:seq>
              <p:cTn id="60" dur="indefinite" nodeType="mainSeq">
                <p:childTnLst>
                  <p:par>
                    <p:cTn id="61" fill="hold">
                      <p:stCondLst>
                        <p:cond delay="0"/>
                      </p:stCondLst>
                      <p:childTnLst>
                        <p:par>
                          <p:cTn id="62" fill="hold">
                            <p:stCondLst>
                              <p:cond delay="0"/>
                            </p:stCondLst>
                            <p:childTnLst>
                              <p:par>
                                <p:cTn id="63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65" fill="hold">
                            <p:stCondLst>
                              <p:cond delay="1500"/>
                            </p:stCondLst>
                            <p:childTnLst>
                              <p:par>
                                <p:cTn id="66" nodeType="afterEffect" fill="hold" presetClass="entr" presetID="1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6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94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228240" y="456840"/>
            <a:ext cx="213372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ccffff"/>
                </a:solidFill>
                <a:latin typeface="Wingdings 2"/>
                <a:ea typeface="Wingdings 2"/>
              </a:rPr>
              <a:t></a:t>
            </a:r>
            <a:r>
              <a:rPr b="0" lang="en-US" sz="4400" spc="-1" strike="noStrike">
                <a:solidFill>
                  <a:srgbClr val="ccffff"/>
                </a:solidFill>
                <a:latin typeface="Tahoma"/>
              </a:rPr>
              <a:t> …</a:t>
            </a:r>
            <a:r>
              <a:rPr b="0" lang="en-US" sz="4400" spc="-1" strike="noStrike">
                <a:solidFill>
                  <a:srgbClr val="ccffff"/>
                </a:solidFill>
                <a:latin typeface="Tahoma"/>
              </a:rPr>
              <a:t>.. 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grpSp>
        <p:nvGrpSpPr>
          <p:cNvPr id="96" name=""/>
          <p:cNvGrpSpPr/>
          <p:nvPr/>
        </p:nvGrpSpPr>
        <p:grpSpPr>
          <a:xfrm>
            <a:off x="1371600" y="1828800"/>
            <a:ext cx="6934320" cy="4684680"/>
            <a:chOff x="1371600" y="1828800"/>
            <a:chExt cx="6934320" cy="4684680"/>
          </a:xfrm>
        </p:grpSpPr>
        <p:grpSp>
          <p:nvGrpSpPr>
            <p:cNvPr id="97" name=""/>
            <p:cNvGrpSpPr/>
            <p:nvPr/>
          </p:nvGrpSpPr>
          <p:grpSpPr>
            <a:xfrm>
              <a:off x="1371600" y="1828800"/>
              <a:ext cx="6934320" cy="4684680"/>
              <a:chOff x="1371600" y="1828800"/>
              <a:chExt cx="6934320" cy="4684680"/>
            </a:xfrm>
          </p:grpSpPr>
          <p:pic>
            <p:nvPicPr>
              <p:cNvPr id="98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371600" y="1828800"/>
                <a:ext cx="6934320" cy="4684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9" name=""/>
              <p:cNvSpPr/>
              <p:nvPr/>
            </p:nvSpPr>
            <p:spPr>
              <a:xfrm>
                <a:off x="3581280" y="3429000"/>
                <a:ext cx="4114800" cy="459000"/>
              </a:xfrm>
              <a:prstGeom prst="rect">
                <a:avLst/>
              </a:prstGeom>
              <a:solidFill>
                <a:srgbClr val="91d5d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3366"/>
                    </a:solidFill>
                    <a:latin typeface="Arial"/>
                  </a:rPr>
                  <a:t>EPAGE is an experimental site to assist in the evaluation of the appropriateness of gastrointestinal endoscopy. </a:t>
                </a:r>
                <a:r>
                  <a:rPr b="1" lang="fr-FR" sz="800" spc="-1" strike="noStrike">
                    <a:solidFill>
                      <a:srgbClr val="000066"/>
                    </a:solidFill>
                    <a:latin typeface="Arial"/>
                  </a:rPr>
                  <a:t>This site is intended for health professional. In no case should it replace the advice of a doctor.</a:t>
                </a:r>
                <a:endParaRPr b="0" lang="en-US" sz="800" spc="-1" strike="noStrike">
                  <a:solidFill>
                    <a:srgbClr val="ffffff"/>
                  </a:solidFill>
                  <a:latin typeface="Times New Roman"/>
                </a:endParaRPr>
              </a:p>
            </p:txBody>
          </p:sp>
        </p:grpSp>
        <p:sp>
          <p:nvSpPr>
            <p:cNvPr id="100" name=""/>
            <p:cNvSpPr/>
            <p:nvPr/>
          </p:nvSpPr>
          <p:spPr>
            <a:xfrm>
              <a:off x="3610440" y="4191120"/>
              <a:ext cx="574920" cy="215640"/>
            </a:xfrm>
            <a:prstGeom prst="rect">
              <a:avLst/>
            </a:prstGeom>
            <a:solidFill>
              <a:srgbClr val="91d5d5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buClr>
                  <a:srgbClr val="ff0066"/>
                </a:buClr>
                <a:buFont typeface="Wingdings 3" charset="2"/>
                <a:buChar char=""/>
                <a:tabLst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ff0066"/>
                  </a:solidFill>
                  <a:latin typeface="Arial"/>
                </a:rPr>
                <a:t> </a:t>
              </a:r>
              <a:r>
                <a:rPr b="1" lang="fr-FR" sz="800" spc="-1" strike="noStrike">
                  <a:solidFill>
                    <a:srgbClr val="ff0066"/>
                  </a:solidFill>
                  <a:latin typeface="Arial"/>
                </a:rPr>
                <a:t>I agree</a:t>
              </a:r>
              <a:endParaRPr b="0" lang="en-US" sz="8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sp>
        <p:nvSpPr>
          <p:cNvPr id="101" name=""/>
          <p:cNvSpPr/>
          <p:nvPr/>
        </p:nvSpPr>
        <p:spPr>
          <a:xfrm rot="13585200">
            <a:off x="4038480" y="4647960"/>
            <a:ext cx="838080" cy="381240"/>
          </a:xfrm>
          <a:custGeom>
            <a:avLst/>
            <a:gdLst>
              <a:gd name="textAreaLeft" fmla="*/ 130680 w 838080"/>
              <a:gd name="textAreaRight" fmla="*/ 733320 w 838080"/>
              <a:gd name="textAreaTop" fmla="*/ 95400 h 381240"/>
              <a:gd name="textAreaBottom" fmla="*/ 286200 h 381240"/>
            </a:gdLst>
            <a:ahLst/>
            <a:rect l="textAreaLeft" t="textAreaTop" r="textAreaRight" b="textAreaBottom"/>
            <a:pathLst>
              <a:path w="21600" h="21600">
                <a:moveTo>
                  <a:pt x="3375" y="5400"/>
                </a:moveTo>
                <a:lnTo>
                  <a:pt x="16200" y="5400"/>
                </a:ln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16200" y="16200"/>
                </a:lnTo>
                <a:lnTo>
                  <a:pt x="3375" y="16200"/>
                </a:lnTo>
                <a:close/>
              </a:path>
              <a:path w="21600" h="21600">
                <a:moveTo>
                  <a:pt x="0" y="5400"/>
                </a:moveTo>
                <a:lnTo>
                  <a:pt x="675" y="5400"/>
                </a:lnTo>
                <a:lnTo>
                  <a:pt x="675" y="16200"/>
                </a:lnTo>
                <a:lnTo>
                  <a:pt x="0" y="16200"/>
                </a:lnTo>
                <a:close/>
              </a:path>
              <a:path w="21600" h="21600">
                <a:moveTo>
                  <a:pt x="1350" y="5400"/>
                </a:moveTo>
                <a:lnTo>
                  <a:pt x="2700" y="5400"/>
                </a:lnTo>
                <a:lnTo>
                  <a:pt x="2700" y="16200"/>
                </a:lnTo>
                <a:lnTo>
                  <a:pt x="1350" y="16200"/>
                </a:lnTo>
                <a:close/>
              </a:path>
            </a:pathLst>
          </a:custGeom>
          <a:solidFill>
            <a:srgbClr val="ff0066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3733920" y="5257800"/>
            <a:ext cx="2895480" cy="82404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66"/>
                </a:solidFill>
                <a:latin typeface="Arial"/>
              </a:rPr>
              <a:t>« This site is intended for health professional. In no case should it replace the advice of a doctor. »</a:t>
            </a: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ffffff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66ff"/>
                </a:solidFill>
                <a:latin typeface="Lucida Sans"/>
              </a:rPr>
              <a:t>If you agree with this, you can enter into the website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3352680" y="3276720"/>
            <a:ext cx="4496040" cy="761760"/>
          </a:xfrm>
          <a:prstGeom prst="ellipse">
            <a:avLst/>
          </a:prstGeom>
          <a:noFill/>
          <a:ln w="38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3429000" y="4114800"/>
            <a:ext cx="1066680" cy="380880"/>
          </a:xfrm>
          <a:prstGeom prst="ellipse">
            <a:avLst/>
          </a:prstGeom>
          <a:noFill/>
          <a:ln w="38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1846440" y="838080"/>
            <a:ext cx="726876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Connection to the Web site</a:t>
            </a:r>
            <a:endParaRPr b="0" lang="en-US" sz="4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timing>
    <p:tnLst>
      <p:par>
        <p:cTn id="68" dur="indefinite" restart="never" nodeType="tmRoot">
          <p:childTnLst>
            <p:seq>
              <p:cTn id="69" dur="indefinite" nodeType="mainSeq">
                <p:childTnLst>
                  <p:par>
                    <p:cTn id="70" fill="hold">
                      <p:stCondLst>
                        <p:cond delay="0"/>
                      </p:stCondLst>
                      <p:childTnLst>
                        <p:par>
                          <p:cTn id="71" fill="hold">
                            <p:stCondLst>
                              <p:cond delay="0"/>
                            </p:stCondLst>
                            <p:childTnLst>
                              <p:par>
                                <p:cTn id="72" nodeType="afterEffect" fill="hold" presetClass="entr" presetID="7" presetSubtype="1">
                                  <p:stCondLst>
                                    <p:cond delay="1000"/>
                                  </p:stCondLst>
                                  <p:iterate type="wd">
                                    <p:tmAbs val="1000"/>
                                  </p:iterate>
                                  <p:childTnLst>
                                    <p:set>
                                      <p:cBhvr>
                                        <p:cTn id="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4" dur="1000" fill="hold"/>
                                        <p:tgtEl>
                                          <p:spTgt spid="9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75" dur="1000" fill="hold"/>
                                        <p:tgtEl>
                                          <p:spTgt spid="9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6" fill="hold">
                            <p:stCondLst>
                              <p:cond delay="4000"/>
                            </p:stCondLst>
                            <p:childTnLst>
                              <p:par>
                                <p:cTn id="77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9" fill="hold">
                            <p:stCondLst>
                              <p:cond delay="5500"/>
                            </p:stCondLst>
                            <p:childTnLst>
                              <p:par>
                                <p:cTn id="80" nodeType="afterEffect" fill="hold" presetClass="entr" presetID="4" presetSubtype="32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8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out)" transition="in">
                                      <p:cBhvr additive="repl">
                                        <p:cTn id="82" dur="500"/>
                                        <p:tgtEl>
                                          <p:spTgt spid="9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3" fill="hold">
                            <p:stCondLst>
                              <p:cond delay="9000"/>
                            </p:stCondLst>
                            <p:childTnLst>
                              <p:par>
                                <p:cTn id="84" nodeType="afterEffect" fill="hold" presetClass="entr" presetID="17" presetSubtype="10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8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repl">
                                        <p:cTn id="86" dur="500" fill="hold"/>
                                        <p:tgtEl>
                                          <p:spTgt spid="103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87" dur="500" fill="hold"/>
                                        <p:tgtEl>
                                          <p:spTgt spid="103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8" fill="hold">
                            <p:stCondLst>
                              <p:cond delay="11500"/>
                            </p:stCondLst>
                            <p:childTnLst>
                              <p:par>
                                <p:cTn id="89" nodeType="afterEffect" fill="hold" presetClass="entr" presetID="2" presetSubtype="4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91" dur="500" fill="hold"/>
                                        <p:tgtEl>
                                          <p:spTgt spid="10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92" dur="500" fill="hold"/>
                                        <p:tgtEl>
                                          <p:spTgt spid="10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set>
                                <p:cBhvr>
                                  <p:cTn id="93" dur="1" fill="hold">
                                    <p:stCondLst>
                                      <p:cond delay="3000"/>
                                    </p:stCondLst>
                                  </p:cTn>
                                  <p:tgtEl>
                                    <p:spTgt spid="103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  <p:par>
                          <p:cTn id="94" fill="hold">
                            <p:stCondLst>
                              <p:cond delay="15000"/>
                            </p:stCondLst>
                            <p:childTnLst>
                              <p:par>
                                <p:cTn id="95" nodeType="afterEffect" fill="hold" presetClass="entr" presetID="4" presetSubtype="16">
                                  <p:stCondLst>
                                    <p:cond delay="6000"/>
                                  </p:stCondLst>
                                  <p:childTnLst>
                                    <p:set>
                                      <p:cBhvr>
                                        <p:cTn id="9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in)" transition="in">
                                      <p:cBhvr additive="repl">
                                        <p:cTn id="97" dur="500"/>
                                        <p:tgtEl>
                                          <p:spTgt spid="10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set>
                                <p:cBhvr>
                                  <p:cTn id="98" dur="1" fill="hold">
                                    <p:stCondLst>
                                      <p:cond delay="6000"/>
                                    </p:stCondLst>
                                  </p:cTn>
                                  <p:tgtEl>
                                    <p:spTgt spid="102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  <p:par>
                          <p:cTn id="99" fill="hold">
                            <p:stCondLst>
                              <p:cond delay="21500"/>
                            </p:stCondLst>
                            <p:childTnLst>
                              <p:par>
                                <p:cTn id="100" nodeType="afterEffect" fill="hold" presetClass="entr" presetID="17" presetSubtype="10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0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repl">
                                        <p:cTn id="102" dur="500" fill="hold"/>
                                        <p:tgtEl>
                                          <p:spTgt spid="104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103" dur="500" fill="hold"/>
                                        <p:tgtEl>
                                          <p:spTgt spid="104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set>
                                <p:cBhvr>
                                  <p:cTn id="104" dur="1" fill="hold">
                                    <p:stCondLst>
                                      <p:cond delay="2000"/>
                                    </p:stCondLst>
                                  </p:cTn>
                                  <p:tgtEl>
                                    <p:spTgt spid="101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228600" y="4568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Choose the procedure …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grpSp>
        <p:nvGrpSpPr>
          <p:cNvPr id="107" name=""/>
          <p:cNvGrpSpPr/>
          <p:nvPr/>
        </p:nvGrpSpPr>
        <p:grpSpPr>
          <a:xfrm>
            <a:off x="1143000" y="1905120"/>
            <a:ext cx="7315200" cy="4779720"/>
            <a:chOff x="1143000" y="1905120"/>
            <a:chExt cx="7315200" cy="4779720"/>
          </a:xfrm>
        </p:grpSpPr>
        <p:pic>
          <p:nvPicPr>
            <p:cNvPr id="108" name="" descr=""/>
            <p:cNvPicPr/>
            <p:nvPr/>
          </p:nvPicPr>
          <p:blipFill>
            <a:blip r:embed="rId1"/>
            <a:stretch/>
          </p:blipFill>
          <p:spPr>
            <a:xfrm>
              <a:off x="1143000" y="1905120"/>
              <a:ext cx="7315200" cy="4779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"/>
            <p:cNvSpPr/>
            <p:nvPr/>
          </p:nvSpPr>
          <p:spPr>
            <a:xfrm>
              <a:off x="2438280" y="3429000"/>
              <a:ext cx="2590920" cy="459000"/>
            </a:xfrm>
            <a:prstGeom prst="rect">
              <a:avLst/>
            </a:prstGeom>
            <a:solidFill>
              <a:srgbClr val="cc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cc0000"/>
                  </a:solidFill>
                  <a:latin typeface="Arial"/>
                </a:rPr>
                <a:t>Upper GI Endoscopy</a:t>
              </a:r>
              <a:r>
                <a:rPr b="1" lang="fr-FR" sz="800" spc="-1" strike="noStrike">
                  <a:solidFill>
                    <a:srgbClr val="ff0066"/>
                  </a:solidFill>
                  <a:latin typeface="Arial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(Clinical Situations</a:t>
              </a:r>
              <a:r>
                <a:rPr b="1" lang="fr-FR" sz="800" spc="-1" strike="noStrike">
                  <a:solidFill>
                    <a:srgbClr val="ff0066"/>
                  </a:solidFill>
                  <a:latin typeface="Arial"/>
                </a:rPr>
                <a:t> </a:t>
              </a:r>
              <a:r>
                <a:rPr b="1" lang="fr-FR" sz="800" spc="-1" strike="noStrike">
                  <a:solidFill>
                    <a:srgbClr val="cc0000"/>
                  </a:solidFill>
                  <a:latin typeface="Arial"/>
                </a:rPr>
                <a:t>1-7</a:t>
              </a: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8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cc0000"/>
                  </a:solidFill>
                  <a:latin typeface="Arial"/>
                </a:rPr>
                <a:t>Colonoscopy </a:t>
              </a:r>
              <a:r>
                <a:rPr b="1" lang="fr-FR" sz="800" spc="-1" strike="noStrike">
                  <a:solidFill>
                    <a:srgbClr val="ff0066"/>
                  </a:solidFill>
                  <a:latin typeface="Arial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(Clinical Situations</a:t>
              </a:r>
              <a:r>
                <a:rPr b="1" lang="fr-FR" sz="800" spc="-1" strike="noStrike">
                  <a:solidFill>
                    <a:srgbClr val="ff0066"/>
                  </a:solidFill>
                  <a:latin typeface="Arial"/>
                </a:rPr>
                <a:t> </a:t>
              </a:r>
              <a:r>
                <a:rPr b="1" lang="fr-FR" sz="800" spc="-1" strike="noStrike">
                  <a:solidFill>
                    <a:srgbClr val="cc0000"/>
                  </a:solidFill>
                  <a:latin typeface="Arial"/>
                </a:rPr>
                <a:t>8-19</a:t>
              </a: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)</a:t>
              </a:r>
              <a:endParaRPr b="0" lang="en-US" sz="8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sp>
        <p:nvSpPr>
          <p:cNvPr id="110" name=""/>
          <p:cNvSpPr/>
          <p:nvPr/>
        </p:nvSpPr>
        <p:spPr>
          <a:xfrm>
            <a:off x="3124080" y="5410080"/>
            <a:ext cx="2301840" cy="64152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66ff"/>
                </a:solidFill>
                <a:latin typeface="Lucida Sans"/>
              </a:rPr>
              <a:t>For this clinic situation, you have to choose the link :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ff0066"/>
                </a:solidFill>
                <a:latin typeface="Lucida Sans"/>
              </a:rPr>
              <a:t>« Upper GI Endoscopy »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 rot="15478200">
            <a:off x="2742840" y="3809520"/>
            <a:ext cx="838440" cy="380880"/>
          </a:xfrm>
          <a:custGeom>
            <a:avLst/>
            <a:gdLst>
              <a:gd name="textAreaLeft" fmla="*/ 131040 w 838440"/>
              <a:gd name="textAreaRight" fmla="*/ 733680 w 838440"/>
              <a:gd name="textAreaTop" fmla="*/ 95040 h 380880"/>
              <a:gd name="textAreaBottom" fmla="*/ 285840 h 380880"/>
            </a:gdLst>
            <a:ahLst/>
            <a:rect l="textAreaLeft" t="textAreaTop" r="textAreaRight" b="textAreaBottom"/>
            <a:pathLst>
              <a:path w="21600" h="21600">
                <a:moveTo>
                  <a:pt x="3375" y="5400"/>
                </a:moveTo>
                <a:lnTo>
                  <a:pt x="16200" y="5400"/>
                </a:ln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16200" y="16200"/>
                </a:lnTo>
                <a:lnTo>
                  <a:pt x="3375" y="16200"/>
                </a:lnTo>
                <a:close/>
              </a:path>
              <a:path w="21600" h="21600">
                <a:moveTo>
                  <a:pt x="0" y="5400"/>
                </a:moveTo>
                <a:lnTo>
                  <a:pt x="675" y="5400"/>
                </a:lnTo>
                <a:lnTo>
                  <a:pt x="675" y="16200"/>
                </a:lnTo>
                <a:lnTo>
                  <a:pt x="0" y="16200"/>
                </a:lnTo>
                <a:close/>
              </a:path>
              <a:path w="21600" h="21600">
                <a:moveTo>
                  <a:pt x="1350" y="5400"/>
                </a:moveTo>
                <a:lnTo>
                  <a:pt x="2700" y="5400"/>
                </a:lnTo>
                <a:lnTo>
                  <a:pt x="2700" y="16200"/>
                </a:lnTo>
                <a:lnTo>
                  <a:pt x="1350" y="16200"/>
                </a:lnTo>
                <a:close/>
              </a:path>
            </a:pathLst>
          </a:custGeom>
          <a:solidFill>
            <a:srgbClr val="ff0066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2362320" y="3352680"/>
            <a:ext cx="1371600" cy="381240"/>
          </a:xfrm>
          <a:prstGeom prst="ellipse">
            <a:avLst/>
          </a:prstGeom>
          <a:noFill/>
          <a:ln w="38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timing>
    <p:tnLst>
      <p:par>
        <p:cTn id="105" dur="indefinite" restart="never" nodeType="tmRoot">
          <p:childTnLst>
            <p:seq>
              <p:cTn id="106" dur="indefinite" nodeType="mainSeq">
                <p:childTnLst>
                  <p:par>
                    <p:cTn id="107" fill="hold">
                      <p:stCondLst>
                        <p:cond delay="0"/>
                      </p:stCondLst>
                      <p:childTnLst>
                        <p:par>
                          <p:cTn id="108" fill="hold">
                            <p:stCondLst>
                              <p:cond delay="0"/>
                            </p:stCondLst>
                            <p:childTnLst>
                              <p:par>
                                <p:cTn id="109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1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1" fill="hold">
                            <p:stCondLst>
                              <p:cond delay="1500"/>
                            </p:stCondLst>
                            <p:childTnLst>
                              <p:par>
                                <p:cTn id="112" nodeType="afterEffect" fill="hold" presetClass="entr" presetID="4" presetSubtype="32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1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out)" transition="in">
                                      <p:cBhvr additive="repl">
                                        <p:cTn id="114" dur="500"/>
                                        <p:tgtEl>
                                          <p:spTgt spid="10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15" fill="hold">
                            <p:stCondLst>
                              <p:cond delay="5000"/>
                            </p:stCondLst>
                            <p:childTnLst>
                              <p:par>
                                <p:cTn id="116" nodeType="afterEffect" fill="hold" presetClass="entr" presetID="2" presetSubtype="4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1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8" dur="500" fill="hold"/>
                                        <p:tgtEl>
                                          <p:spTgt spid="11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9" dur="500" fill="hold"/>
                                        <p:tgtEl>
                                          <p:spTgt spid="11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0" fill="hold">
                            <p:stCondLst>
                              <p:cond delay="8500"/>
                            </p:stCondLst>
                            <p:childTnLst>
                              <p:par>
                                <p:cTn id="121" nodeType="afterEffect" fill="hold" presetClass="entr" presetID="4" presetSubtype="16">
                                  <p:stCondLst>
                                    <p:cond delay="6000"/>
                                  </p:stCondLst>
                                  <p:childTnLst>
                                    <p:set>
                                      <p:cBhvr>
                                        <p:cTn id="1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in)" transition="in">
                                      <p:cBhvr additive="repl">
                                        <p:cTn id="123" dur="500"/>
                                        <p:tgtEl>
                                          <p:spTgt spid="1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set>
                                <p:cBhvr>
                                  <p:cTn id="124" dur="1" fill="hold">
                                    <p:stCondLst>
                                      <p:cond delay="6000"/>
                                    </p:stCondLst>
                                  </p:cTn>
                                  <p:tgtEl>
                                    <p:spTgt spid="110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  <p:par>
                          <p:cTn id="125" fill="hold">
                            <p:stCondLst>
                              <p:cond delay="15000"/>
                            </p:stCondLst>
                            <p:childTnLst>
                              <p:par>
                                <p:cTn id="126" nodeType="afterEffect" fill="hold" presetClass="entr" presetID="17" presetSubtype="10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repl">
                                        <p:cTn id="128" dur="500" fill="hold"/>
                                        <p:tgtEl>
                                          <p:spTgt spid="112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129" dur="500" fill="hold"/>
                                        <p:tgtEl>
                                          <p:spTgt spid="112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set>
                                <p:cBhvr>
                                  <p:cTn id="130" dur="1" fill="hold">
                                    <p:stCondLst>
                                      <p:cond delay="2000"/>
                                    </p:stCondLst>
                                  </p:cTn>
                                  <p:tgtEl>
                                    <p:spTgt spid="111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228600" y="380520"/>
            <a:ext cx="77724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Choose the chapter …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pic>
        <p:nvPicPr>
          <p:cNvPr id="114" name="" descr=""/>
          <p:cNvPicPr/>
          <p:nvPr/>
        </p:nvPicPr>
        <p:blipFill>
          <a:blip r:embed="rId1"/>
          <a:stretch/>
        </p:blipFill>
        <p:spPr>
          <a:xfrm>
            <a:off x="1143000" y="1676520"/>
            <a:ext cx="6977160" cy="4944960"/>
          </a:xfrm>
          <a:prstGeom prst="rect">
            <a:avLst/>
          </a:prstGeom>
          <a:ln w="0">
            <a:noFill/>
          </a:ln>
        </p:spPr>
      </p:pic>
      <p:sp>
        <p:nvSpPr>
          <p:cNvPr id="115" name=""/>
          <p:cNvSpPr/>
          <p:nvPr/>
        </p:nvSpPr>
        <p:spPr>
          <a:xfrm>
            <a:off x="2743200" y="4038480"/>
            <a:ext cx="1523880" cy="304920"/>
          </a:xfrm>
          <a:prstGeom prst="ellipse">
            <a:avLst/>
          </a:prstGeom>
          <a:noFill/>
          <a:ln w="38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4343400" y="5638680"/>
            <a:ext cx="2971800" cy="45900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66ff"/>
                </a:solidFill>
                <a:latin typeface="Lucida Sans"/>
              </a:rPr>
              <a:t>To enter into the chapter, choose :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ff0066"/>
                </a:solidFill>
                <a:latin typeface="Lucida Sans"/>
              </a:rPr>
              <a:t>« Known Barrett’s esophagus »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 rot="15478200">
            <a:off x="3504960" y="4648320"/>
            <a:ext cx="838080" cy="380880"/>
          </a:xfrm>
          <a:custGeom>
            <a:avLst/>
            <a:gdLst>
              <a:gd name="textAreaLeft" fmla="*/ 130680 w 838080"/>
              <a:gd name="textAreaRight" fmla="*/ 733320 w 838080"/>
              <a:gd name="textAreaTop" fmla="*/ 95040 h 380880"/>
              <a:gd name="textAreaBottom" fmla="*/ 285840 h 380880"/>
            </a:gdLst>
            <a:ahLst/>
            <a:rect l="textAreaLeft" t="textAreaTop" r="textAreaRight" b="textAreaBottom"/>
            <a:pathLst>
              <a:path w="21600" h="21600">
                <a:moveTo>
                  <a:pt x="3375" y="5400"/>
                </a:moveTo>
                <a:lnTo>
                  <a:pt x="16200" y="5400"/>
                </a:ln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16200" y="16200"/>
                </a:lnTo>
                <a:lnTo>
                  <a:pt x="3375" y="16200"/>
                </a:lnTo>
                <a:close/>
              </a:path>
              <a:path w="21600" h="21600">
                <a:moveTo>
                  <a:pt x="0" y="5400"/>
                </a:moveTo>
                <a:lnTo>
                  <a:pt x="675" y="5400"/>
                </a:lnTo>
                <a:lnTo>
                  <a:pt x="675" y="16200"/>
                </a:lnTo>
                <a:lnTo>
                  <a:pt x="0" y="16200"/>
                </a:lnTo>
                <a:close/>
              </a:path>
              <a:path w="21600" h="21600">
                <a:moveTo>
                  <a:pt x="1350" y="5400"/>
                </a:moveTo>
                <a:lnTo>
                  <a:pt x="2700" y="5400"/>
                </a:lnTo>
                <a:lnTo>
                  <a:pt x="2700" y="16200"/>
                </a:lnTo>
                <a:lnTo>
                  <a:pt x="1350" y="16200"/>
                </a:lnTo>
                <a:close/>
              </a:path>
            </a:pathLst>
          </a:custGeom>
          <a:solidFill>
            <a:srgbClr val="ff0066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timing>
    <p:tnLst>
      <p:par>
        <p:cTn id="131" dur="indefinite" restart="never" nodeType="tmRoot">
          <p:childTnLst>
            <p:seq>
              <p:cTn id="132" dur="indefinite" nodeType="mainSeq">
                <p:childTnLst>
                  <p:par>
                    <p:cTn id="133" fill="hold">
                      <p:stCondLst>
                        <p:cond delay="0"/>
                      </p:stCondLst>
                      <p:childTnLst>
                        <p:par>
                          <p:cTn id="134" fill="hold">
                            <p:stCondLst>
                              <p:cond delay="0"/>
                            </p:stCondLst>
                            <p:childTnLst>
                              <p:par>
                                <p:cTn id="135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3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7" fill="hold">
                            <p:stCondLst>
                              <p:cond delay="1500"/>
                            </p:stCondLst>
                            <p:childTnLst>
                              <p:par>
                                <p:cTn id="138" nodeType="afterEffect" fill="hold" presetClass="entr" presetID="4" presetSubtype="32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out)" transition="in">
                                      <p:cBhvr additive="repl">
                                        <p:cTn id="140" dur="500"/>
                                        <p:tgtEl>
                                          <p:spTgt spid="1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1" fill="hold">
                            <p:stCondLst>
                              <p:cond delay="4000"/>
                            </p:stCondLst>
                            <p:childTnLst>
                              <p:par>
                                <p:cTn id="142" nodeType="afterEffect" fill="hold" presetClass="entr" presetID="2" presetSubtype="4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1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44" dur="500" fill="hold"/>
                                        <p:tgtEl>
                                          <p:spTgt spid="11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5" dur="500" fill="hold"/>
                                        <p:tgtEl>
                                          <p:spTgt spid="11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6" fill="hold">
                            <p:stCondLst>
                              <p:cond delay="7500"/>
                            </p:stCondLst>
                            <p:childTnLst>
                              <p:par>
                                <p:cTn id="147" nodeType="afterEffect" fill="hold" presetClass="entr" presetID="4" presetSubtype="16">
                                  <p:stCondLst>
                                    <p:cond delay="6000"/>
                                  </p:stCondLst>
                                  <p:childTnLst>
                                    <p:set>
                                      <p:cBhvr>
                                        <p:cTn id="1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in)" transition="in">
                                      <p:cBhvr additive="repl">
                                        <p:cTn id="149" dur="500"/>
                                        <p:tgtEl>
                                          <p:spTgt spid="1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set>
                                <p:cBhvr>
                                  <p:cTn id="150" dur="1" fill="hold">
                                    <p:stCondLst>
                                      <p:cond delay="6000"/>
                                    </p:stCondLst>
                                  </p:cTn>
                                  <p:tgtEl>
                                    <p:spTgt spid="116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  <p:par>
                          <p:cTn id="151" fill="hold">
                            <p:stCondLst>
                              <p:cond delay="14000"/>
                            </p:stCondLst>
                            <p:childTnLst>
                              <p:par>
                                <p:cTn id="152" nodeType="afterEffect" fill="hold" presetClass="entr" presetID="17" presetSubtype="10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repl">
                                        <p:cTn id="154" dur="500" fill="hold"/>
                                        <p:tgtEl>
                                          <p:spTgt spid="11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155" dur="500" fill="hold"/>
                                        <p:tgtEl>
                                          <p:spTgt spid="11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set>
                                <p:cBhvr>
                                  <p:cTn id="156" dur="1" fill="hold">
                                    <p:stCondLst>
                                      <p:cond delay="2000"/>
                                    </p:stCondLst>
                                  </p:cTn>
                                  <p:tgtEl>
                                    <p:spTgt spid="117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66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title"/>
          </p:nvPr>
        </p:nvSpPr>
        <p:spPr>
          <a:xfrm>
            <a:off x="152280" y="228600"/>
            <a:ext cx="7772400" cy="838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4400" spc="-1" strike="noStrike">
                <a:solidFill>
                  <a:srgbClr val="ccffff"/>
                </a:solidFill>
                <a:latin typeface="Tahoma"/>
              </a:rPr>
              <a:t>Advance into the chapter …</a:t>
            </a:r>
            <a:endParaRPr b="0" lang="en-US" sz="4400" spc="-1" strike="noStrike">
              <a:solidFill>
                <a:srgbClr val="ccffff"/>
              </a:solidFill>
              <a:latin typeface="Tahoma"/>
            </a:endParaRPr>
          </a:p>
        </p:txBody>
      </p:sp>
      <p:pic>
        <p:nvPicPr>
          <p:cNvPr id="119" name="" descr=""/>
          <p:cNvPicPr/>
          <p:nvPr/>
        </p:nvPicPr>
        <p:blipFill>
          <a:blip r:embed="rId1"/>
          <a:stretch/>
        </p:blipFill>
        <p:spPr>
          <a:xfrm>
            <a:off x="914400" y="1447920"/>
            <a:ext cx="7400880" cy="5267160"/>
          </a:xfrm>
          <a:prstGeom prst="rect">
            <a:avLst/>
          </a:prstGeom>
          <a:ln w="0">
            <a:noFill/>
          </a:ln>
        </p:spPr>
      </p:pic>
      <p:sp>
        <p:nvSpPr>
          <p:cNvPr id="120" name=""/>
          <p:cNvSpPr/>
          <p:nvPr/>
        </p:nvSpPr>
        <p:spPr>
          <a:xfrm>
            <a:off x="3124080" y="4114800"/>
            <a:ext cx="1828800" cy="304920"/>
          </a:xfrm>
          <a:prstGeom prst="ellipse">
            <a:avLst/>
          </a:prstGeom>
          <a:noFill/>
          <a:ln w="38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5410080" y="4952880"/>
            <a:ext cx="2590920" cy="64152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66ff"/>
                </a:solidFill>
                <a:latin typeface="Lucida Sans"/>
              </a:rPr>
              <a:t>The last gastroscopy was made  3 years ago, so choose :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ff0066"/>
                </a:solidFill>
                <a:latin typeface="Lucida Sans"/>
              </a:rPr>
              <a:t>« Last endoscopy &gt;= 2 years »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 rot="13857000">
            <a:off x="4266720" y="4571280"/>
            <a:ext cx="838080" cy="381240"/>
          </a:xfrm>
          <a:custGeom>
            <a:avLst/>
            <a:gdLst>
              <a:gd name="textAreaLeft" fmla="*/ 130680 w 838080"/>
              <a:gd name="textAreaRight" fmla="*/ 733320 w 838080"/>
              <a:gd name="textAreaTop" fmla="*/ 95400 h 381240"/>
              <a:gd name="textAreaBottom" fmla="*/ 286200 h 381240"/>
            </a:gdLst>
            <a:ahLst/>
            <a:rect l="textAreaLeft" t="textAreaTop" r="textAreaRight" b="textAreaBottom"/>
            <a:pathLst>
              <a:path w="21600" h="21600">
                <a:moveTo>
                  <a:pt x="3375" y="5400"/>
                </a:moveTo>
                <a:lnTo>
                  <a:pt x="16200" y="5400"/>
                </a:ln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16200" y="16200"/>
                </a:lnTo>
                <a:lnTo>
                  <a:pt x="3375" y="16200"/>
                </a:lnTo>
                <a:close/>
              </a:path>
              <a:path w="21600" h="21600">
                <a:moveTo>
                  <a:pt x="0" y="5400"/>
                </a:moveTo>
                <a:lnTo>
                  <a:pt x="675" y="5400"/>
                </a:lnTo>
                <a:lnTo>
                  <a:pt x="675" y="16200"/>
                </a:lnTo>
                <a:lnTo>
                  <a:pt x="0" y="16200"/>
                </a:lnTo>
                <a:close/>
              </a:path>
              <a:path w="21600" h="21600">
                <a:moveTo>
                  <a:pt x="1350" y="5400"/>
                </a:moveTo>
                <a:lnTo>
                  <a:pt x="2700" y="5400"/>
                </a:lnTo>
                <a:lnTo>
                  <a:pt x="2700" y="16200"/>
                </a:lnTo>
                <a:lnTo>
                  <a:pt x="1350" y="16200"/>
                </a:lnTo>
                <a:close/>
              </a:path>
            </a:pathLst>
          </a:custGeom>
          <a:solidFill>
            <a:srgbClr val="ff0066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timing>
    <p:tnLst>
      <p:par>
        <p:cTn id="157" dur="indefinite" restart="never" nodeType="tmRoot">
          <p:childTnLst>
            <p:seq>
              <p:cTn id="158" dur="indefinite" nodeType="mainSeq">
                <p:childTnLst>
                  <p:par>
                    <p:cTn id="159" fill="hold">
                      <p:stCondLst>
                        <p:cond delay="0"/>
                      </p:stCondLst>
                      <p:childTnLst>
                        <p:par>
                          <p:cTn id="160" fill="hold">
                            <p:stCondLst>
                              <p:cond delay="0"/>
                            </p:stCondLst>
                            <p:childTnLst>
                              <p:par>
                                <p:cTn id="161" nodeType="afterEffect" fill="hold" presetClass="entr" presetID="1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16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3" fill="hold">
                            <p:stCondLst>
                              <p:cond delay="1500"/>
                            </p:stCondLst>
                            <p:childTnLst>
                              <p:par>
                                <p:cTn id="164" nodeType="afterEffect" fill="hold" presetClass="entr" presetID="4" presetSubtype="32">
                                  <p:stCondLst>
                                    <p:cond delay="2000"/>
                                  </p:stCondLst>
                                  <p:childTnLst>
                                    <p:set>
                                      <p:cBhvr>
                                        <p:cTn id="1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out)" transition="in">
                                      <p:cBhvr additive="repl">
                                        <p:cTn id="166" dur="500"/>
                                        <p:tgtEl>
                                          <p:spTgt spid="1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7" fill="hold">
                            <p:stCondLst>
                              <p:cond delay="4000"/>
                            </p:stCondLst>
                            <p:childTnLst>
                              <p:par>
                                <p:cTn id="168" nodeType="afterEffect" fill="hold" presetClass="entr" presetID="2" presetSubtype="4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1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70" dur="500" fill="hold"/>
                                        <p:tgtEl>
                                          <p:spTgt spid="12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1" dur="500" fill="hold"/>
                                        <p:tgtEl>
                                          <p:spTgt spid="12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2" fill="hold">
                            <p:stCondLst>
                              <p:cond delay="7500"/>
                            </p:stCondLst>
                            <p:childTnLst>
                              <p:par>
                                <p:cTn id="173" nodeType="afterEffect" fill="hold" presetClass="entr" presetID="4" presetSubtype="16">
                                  <p:stCondLst>
                                    <p:cond delay="5000"/>
                                  </p:stCondLst>
                                  <p:childTnLst>
                                    <p:set>
                                      <p:cBhvr>
                                        <p:cTn id="1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box(in)" transition="in">
                                      <p:cBhvr additive="repl">
                                        <p:cTn id="175" dur="500"/>
                                        <p:tgtEl>
                                          <p:spTgt spid="1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set>
                                <p:cBhvr>
                                  <p:cTn id="176" dur="1" fill="hold">
                                    <p:stCondLst>
                                      <p:cond delay="5000"/>
                                    </p:stCondLst>
                                  </p:cTn>
                                  <p:tgtEl>
                                    <p:spTgt spid="121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  <p:par>
                          <p:cTn id="177" fill="hold">
                            <p:stCondLst>
                              <p:cond delay="13000"/>
                            </p:stCondLst>
                            <p:childTnLst>
                              <p:par>
                                <p:cTn id="178" nodeType="afterEffect" fill="hold" presetClass="entr" presetID="17" presetSubtype="10">
                                  <p:stCondLst>
                                    <p:cond delay="3000"/>
                                  </p:stCondLst>
                                  <p:childTnLst>
                                    <p:set>
                                      <p:cBhvr>
                                        <p:cTn id="1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repl">
                                        <p:cTn id="180" dur="500" fill="hold"/>
                                        <p:tgtEl>
                                          <p:spTgt spid="120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repl">
                                        <p:cTn id="181" dur="500" fill="hold"/>
                                        <p:tgtEl>
                                          <p:spTgt spid="120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set>
                                <p:cBhvr>
                                  <p:cTn id="182" dur="1" fill="hold">
                                    <p:stCondLst>
                                      <p:cond delay="3000"/>
                                    </p:stCondLst>
                                  </p:cTn>
                                  <p:tgtEl>
                                    <p:spTgt spid="122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1-11-20T07:28:10Z</dcterms:created>
  <dc:creator>VPittet</dc:creator>
  <dc:description/>
  <dc:language>en-US</dc:language>
  <cp:lastModifiedBy>Gunther Eysenbach</cp:lastModifiedBy>
  <dcterms:modified xsi:type="dcterms:W3CDTF">2003-06-09T14:52:25Z</dcterms:modified>
  <cp:revision>29</cp:revision>
  <dc:subject/>
  <dc:title>Utilisation des guidelines médicaux via le World Wide Web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316890740</vt:r8>
  </property>
  <property fmtid="{D5CDD505-2E9C-101B-9397-08002B2CF9AE}" pid="3" name="_AuthorEmail">
    <vt:lpwstr>geysenba@uhnres.utoronto.ca</vt:lpwstr>
  </property>
  <property fmtid="{D5CDD505-2E9C-101B-9397-08002B2CF9AE}" pid="4" name="_AuthorEmailDisplayName">
    <vt:lpwstr>Dr. Gunther Eysenbach</vt:lpwstr>
  </property>
  <property fmtid="{D5CDD505-2E9C-101B-9397-08002B2CF9AE}" pid="5" name="_EmailSubject">
    <vt:lpwstr>2002061001</vt:lpwstr>
  </property>
</Properties>
</file>